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BA7CFA-E07E-4BAB-94B6-101D6919F9D1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7FF47B-D57A-430D-B271-DF6C0C12C18D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97F181-3D6D-4F52-A82F-7CE6B1D0F888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B6CD61-6C49-448A-8B28-025A6915F5B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85015-CB6F-4A9F-AA11-1C93E191DC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A1221-9034-41C3-9AEB-B8D83B3F42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FDB26-5CAC-4A27-B67D-12E688BD7A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74569-EFC2-4D2E-9E5A-AD34561319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1A323-7495-4040-A759-0C0E2A6057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D57FA-C2BB-4D27-A54D-C120220E7A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4C009-9666-46E2-B900-3D1EE92D4D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971CF-E4DB-42B6-BCC3-7469B329D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84AD5-3517-4142-97CB-93B66D1D36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09388-8E4D-48E4-9707-FBBD7B34E4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66A6E-4C77-4C47-9C1C-7241BE4433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B577F-B3A2-4D1A-992D-6A4BF3E51C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143924-3D3B-4B9D-B84B-8B331F40819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2322360" y="252360"/>
            <a:ext cx="4515120" cy="832176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4"/>
          <p:cNvSpPr/>
          <p:nvPr/>
        </p:nvSpPr>
        <p:spPr>
          <a:xfrm>
            <a:off x="52560" y="64440"/>
            <a:ext cx="2201760" cy="246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: The genetics of quantitative disease resistance 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. solanacearum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MI1000 strain identified by GWA mapping at all stages of infection at 27°C in the CUT condition of inocul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reen arrow highlights the major QTL of resistance detected on the long arm of chromosome V, from 7 dai until 13 dai with an increasing significance. dai: days after inocul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7" descr=""/>
          <p:cNvPicPr/>
          <p:nvPr/>
        </p:nvPicPr>
        <p:blipFill>
          <a:blip r:embed="rId1"/>
          <a:stretch/>
        </p:blipFill>
        <p:spPr>
          <a:xfrm>
            <a:off x="2343240" y="193680"/>
            <a:ext cx="4514760" cy="824076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4"/>
          <p:cNvSpPr/>
          <p:nvPr/>
        </p:nvSpPr>
        <p:spPr>
          <a:xfrm>
            <a:off x="52560" y="71640"/>
            <a:ext cx="2244600" cy="31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: The genetics of quantitative disease resistance 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. solanacearum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MI1000 strain identified by GWA mapping at all stages of infection at 27°C in the UNCUT condition of inocul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reen arrow highlights the major QTL of resistance detected on the long arm of chromosome V, from 6 dai until 13 dai with an increasing significance. The red arrow highlights the major QTL of resistance detected at the beginning of chromosome IV from 9 dai until 13 dai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3" descr=""/>
          <p:cNvPicPr/>
          <p:nvPr/>
        </p:nvPicPr>
        <p:blipFill>
          <a:blip r:embed="rId1"/>
          <a:stretch/>
        </p:blipFill>
        <p:spPr>
          <a:xfrm>
            <a:off x="2317680" y="155520"/>
            <a:ext cx="4540320" cy="576252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4"/>
          <p:cNvSpPr/>
          <p:nvPr/>
        </p:nvSpPr>
        <p:spPr>
          <a:xfrm>
            <a:off x="33480" y="63720"/>
            <a:ext cx="221904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enetics of quantitative disease resistance 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. solanacearum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MI1000 strain identified by GWA mapping at all stages of infection at 30°C in the CUT condition of inocul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reen arrow highlights the major QTL of resistance detected on the chromosome III at 4 dai and 5 dai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ZoneTexte 2"/>
          <p:cNvSpPr/>
          <p:nvPr/>
        </p:nvSpPr>
        <p:spPr>
          <a:xfrm>
            <a:off x="44280" y="44280"/>
            <a:ext cx="2152800" cy="28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enetics of quantitative disease resistance 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. solanacearum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MI1000 identified by GWA mapping at all stages of infection at 30°C in the UNCUT condition of inocula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red arrow highlights a QTL of resistance detected at the end of chromosome III and the green arrow highlights on a second QTL of resistance detected at the beginning of chromosome V at 6 dai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2" descr=""/>
          <p:cNvPicPr/>
          <p:nvPr/>
        </p:nvPicPr>
        <p:blipFill>
          <a:blip r:embed="rId1"/>
          <a:stretch/>
        </p:blipFill>
        <p:spPr>
          <a:xfrm>
            <a:off x="2141640" y="223920"/>
            <a:ext cx="4716360" cy="4994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2008080" y="185760"/>
            <a:ext cx="4724640" cy="8958240"/>
          </a:xfrm>
          <a:prstGeom prst="rect">
            <a:avLst/>
          </a:prstGeom>
          <a:ln w="0">
            <a:noFill/>
          </a:ln>
        </p:spPr>
      </p:pic>
      <p:sp>
        <p:nvSpPr>
          <p:cNvPr id="57" name="Rectangle 2"/>
          <p:cNvSpPr/>
          <p:nvPr/>
        </p:nvSpPr>
        <p:spPr>
          <a:xfrm>
            <a:off x="142920" y="189000"/>
            <a:ext cx="182880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uantile-Quantile plots of p-values (negative logarithm and EMMAX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 all stages of infection at 27°C in the CUT and UNCUT conditions of inoculation. Solid line: expected, dashed line: EMMAX with MARF &gt; 10%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1944720" y="439560"/>
            <a:ext cx="4724280" cy="662148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2"/>
          <p:cNvSpPr/>
          <p:nvPr/>
        </p:nvSpPr>
        <p:spPr>
          <a:xfrm>
            <a:off x="142920" y="509760"/>
            <a:ext cx="182880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uantile-Quantile plots of p-values (negative logarithm and EMMAX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 all stages of infection at 30°C in the CUT and UNCUT conditions of inoculation. Solid line: expected, dashed line: EMMAX with MARF &gt; 10%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ZoneTexte 1"/>
          <p:cNvSpPr/>
          <p:nvPr/>
        </p:nvSpPr>
        <p:spPr>
          <a:xfrm>
            <a:off x="825480" y="4614840"/>
            <a:ext cx="52959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: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level of 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3g51420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3g51430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wild type Col-0 background and in corresponding  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4-1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4-2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5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s, homozygous for the T-DNA insertion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values are means (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–(Cqsample-CqR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±SD of the mean (n =6) from two independent repetitions. Cq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R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s the average Cq value calculated on the basis of results obtained for two best reference gene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sen for their consistent expression in all samples tested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6039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098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s values were normalized to those obtained in Col-0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2" descr=""/>
          <p:cNvPicPr/>
          <p:nvPr/>
        </p:nvPicPr>
        <p:blipFill>
          <a:blip r:embed="rId1"/>
          <a:stretch/>
        </p:blipFill>
        <p:spPr>
          <a:xfrm>
            <a:off x="1301760" y="1052640"/>
            <a:ext cx="4219560" cy="316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10" descr=""/>
          <p:cNvPicPr/>
          <p:nvPr/>
        </p:nvPicPr>
        <p:blipFill>
          <a:blip r:embed="rId1"/>
          <a:stretch/>
        </p:blipFill>
        <p:spPr>
          <a:xfrm>
            <a:off x="1758960" y="220680"/>
            <a:ext cx="3030480" cy="6775560"/>
          </a:xfrm>
          <a:prstGeom prst="rect">
            <a:avLst/>
          </a:prstGeom>
          <a:ln w="0">
            <a:noFill/>
          </a:ln>
        </p:spPr>
      </p:pic>
      <p:sp>
        <p:nvSpPr>
          <p:cNvPr id="63" name="ZoneTexte 1"/>
          <p:cNvSpPr/>
          <p:nvPr/>
        </p:nvSpPr>
        <p:spPr>
          <a:xfrm>
            <a:off x="755640" y="7439040"/>
            <a:ext cx="5295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: Representative symptoms observed at 5 dai at 30°C for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4-1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4-2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l5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s compared to Col-0 susceptible plant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Four weeks old plants were inoculated using the CUT inoculation method with a bacterial suspension of 1.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7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acteria/mL and transferred at 30°C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21T15:46:23Z</dcterms:created>
  <dc:creator>rberthome</dc:creator>
  <dc:description/>
  <dc:language>en-US</dc:language>
  <cp:lastModifiedBy>Revathi M.</cp:lastModifiedBy>
  <dcterms:modified xsi:type="dcterms:W3CDTF">2017-08-17T08:33:26Z</dcterms:modified>
  <cp:revision>77</cp:revision>
  <dc:subject/>
  <dc:title>Diapositiv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Out To">
    <vt:lpwstr/>
  </property>
  <property fmtid="{D5CDD505-2E9C-101B-9397-08002B2CF9AE}" pid="3" name="DocumentId">
    <vt:lpwstr>Presentation 1.PPT</vt:lpwstr>
  </property>
  <property fmtid="{D5CDD505-2E9C-101B-9397-08002B2CF9AE}" pid="4" name="DocumentType">
    <vt:lpwstr>Presentation</vt:lpwstr>
  </property>
  <property fmtid="{D5CDD505-2E9C-101B-9397-08002B2CF9AE}" pid="5" name="FileFormat">
    <vt:lpwstr>PPT</vt:lpwstr>
  </property>
  <property fmtid="{D5CDD505-2E9C-101B-9397-08002B2CF9AE}" pid="6" name="IsDeleted">
    <vt:lpwstr>0</vt:lpwstr>
  </property>
  <property fmtid="{D5CDD505-2E9C-101B-9397-08002B2CF9AE}" pid="7" name="StageName">
    <vt:lpwstr/>
  </property>
  <property fmtid="{D5CDD505-2E9C-101B-9397-08002B2CF9AE}" pid="8" name="TitleName">
    <vt:lpwstr>Presentation 1.PPT</vt:lpwstr>
  </property>
</Properties>
</file>